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57" r:id="rId2"/>
    <p:sldId id="258" r:id="rId3"/>
    <p:sldId id="259" r:id="rId4"/>
    <p:sldId id="262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477"/>
    <p:restoredTop sz="94694"/>
  </p:normalViewPr>
  <p:slideViewPr>
    <p:cSldViewPr snapToGrid="0">
      <p:cViewPr>
        <p:scale>
          <a:sx n="78" d="100"/>
          <a:sy n="78" d="100"/>
        </p:scale>
        <p:origin x="888" y="11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A606EC-F80A-C44E-9A4F-BD31CBC6104F}" type="datetimeFigureOut">
              <a:rPr lang="en-US" smtClean="0"/>
              <a:t>2/27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D97255-04E3-EA44-A4DB-958FE9AD2B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56457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3" Type="http://schemas.openxmlformats.org/officeDocument/2006/relationships/hyperlink" Target="https://radiopaedia.org/cases/normal-chest-x-ray" TargetMode="External"/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Inferior STEMI Example #3. In: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Buttner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R, Burns RB and E. Life in the Fast Lane. March 21, 2023. https://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litfl.com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/inferior-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stemi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-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ecg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-library/. 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ED97255-04E3-EA44-A4DB-958FE9AD2BD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864641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Gaillard F. Normal Chest X-ray: Radiology case: In: </a:t>
            </a:r>
            <a:r>
              <a:rPr lang="en-US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Radiopaedia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lang="en-US" sz="1800" u="sng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  <a:hlinkClick r:id="rId3"/>
              </a:rPr>
              <a:t>https://radiopaedia.org/cases/normal-chest-x-ray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ED97255-04E3-EA44-A4DB-958FE9AD2BD0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0409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BF0B23-7957-1899-C6B0-53118C482CF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890673E-B9DC-BAED-D754-DFEAE62DDAE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00E232-DD33-E6DD-4D6A-4632AC31DA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049CF-3B41-CE4E-A914-E9AF9A7E19C3}" type="datetimeFigureOut">
              <a:rPr lang="en-US" smtClean="0"/>
              <a:t>2/2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D239F4-6632-22BB-8028-18F18F3516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171CD1-35FC-73F9-E9FB-56E064F68C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8E3E5-F1FD-DF45-89A5-58399262ED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20972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2B73D3-0FBE-E479-E2F8-761030EC9F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D7EE051-9D32-F375-4479-3079CEE13C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B862AB-8189-6CEC-22F2-D0F150EDB0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049CF-3B41-CE4E-A914-E9AF9A7E19C3}" type="datetimeFigureOut">
              <a:rPr lang="en-US" smtClean="0"/>
              <a:t>2/2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B6F660-256A-BC82-2129-05BC198CBC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DD0722-1CC3-75E3-BDBE-62FB8D6583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8E3E5-F1FD-DF45-89A5-58399262ED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2402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AD4BC29-52AA-255E-A17D-33AAA6F9F6D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457F2D1-66C7-DA8B-8CA1-5657D2CC97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73DFA6-B7E9-36D7-8DAD-7594ECD63B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049CF-3B41-CE4E-A914-E9AF9A7E19C3}" type="datetimeFigureOut">
              <a:rPr lang="en-US" smtClean="0"/>
              <a:t>2/2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18C1A3-EC7C-4D3E-6538-B39DACD873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2B17F2-51E1-613E-97CB-5E9C35EE55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8E3E5-F1FD-DF45-89A5-58399262ED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251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DD19F8-3F26-D698-9040-6FFBB74CA7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6670CB-1EE0-1DE1-C8D6-2F4A76ED088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8175EC-34D0-6AB0-F290-BE5E4CCED7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049CF-3B41-CE4E-A914-E9AF9A7E19C3}" type="datetimeFigureOut">
              <a:rPr lang="en-US" smtClean="0"/>
              <a:t>2/2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684CB6-2F7E-A8B9-F5C2-710C9791B1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5D3DCA-4876-E4D4-37FD-1DD0783142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8E3E5-F1FD-DF45-89A5-58399262ED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28107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5DBB26-9037-E334-EF47-78C26313AB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1EF0300-34D7-871D-8BD0-9A3EAB7A07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B280BA-D4D2-B683-8320-8661B09FC4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049CF-3B41-CE4E-A914-E9AF9A7E19C3}" type="datetimeFigureOut">
              <a:rPr lang="en-US" smtClean="0"/>
              <a:t>2/2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71FDC7-2BC3-3313-E7D7-954B786B98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828D97-3BDF-7CA4-0C64-6C8F768BDF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8E3E5-F1FD-DF45-89A5-58399262ED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52740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37DCFB-334E-B110-D4E6-3014EA0E84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0A4BD9-155E-71EA-52FF-691D3C21CF6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4A68110-25FA-1558-AAF4-B84D03ACBB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528374-6471-1CE1-D1C9-7B44CCD972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049CF-3B41-CE4E-A914-E9AF9A7E19C3}" type="datetimeFigureOut">
              <a:rPr lang="en-US" smtClean="0"/>
              <a:t>2/27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6D64E8E-B875-DC7A-7BEB-40CAAD1945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5F997F2-8D1C-15D2-0A7B-F7F1A67987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8E3E5-F1FD-DF45-89A5-58399262ED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26337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0363CD-884C-2B84-6763-59545BD992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5C04D0-A49F-9EF3-65EA-2401D13D0B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BFE8CE-5883-DDD0-A64A-861DCD554E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3796CA1-19FA-E465-6303-2299393AC7E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74B6745-6517-CFC0-B90C-B36B49D452C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A331A4E-D917-9579-D930-3E4227450F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049CF-3B41-CE4E-A914-E9AF9A7E19C3}" type="datetimeFigureOut">
              <a:rPr lang="en-US" smtClean="0"/>
              <a:t>2/27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59E6DC4-045E-CD5F-28D3-C25904BCC1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86A65B2-5323-5A13-259E-7B7EBC118C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8E3E5-F1FD-DF45-89A5-58399262ED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2165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31F2A5-1BC1-0936-EA35-7B5D320559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D4559F6-F3D3-8073-9F72-C04CFCB717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049CF-3B41-CE4E-A914-E9AF9A7E19C3}" type="datetimeFigureOut">
              <a:rPr lang="en-US" smtClean="0"/>
              <a:t>2/27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ECE5759-A9B6-8DBD-1ABC-63153FEBD7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B8336D9-108F-8B5F-81BF-F9E49EFFF6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8E3E5-F1FD-DF45-89A5-58399262ED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03548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5BE7FF6-0B7A-EA32-18C8-F243B25E90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049CF-3B41-CE4E-A914-E9AF9A7E19C3}" type="datetimeFigureOut">
              <a:rPr lang="en-US" smtClean="0"/>
              <a:t>2/27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F68F882-C92D-B11B-5F55-099ADDB1CE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1C0724E-E135-FCB2-179C-597F2CD0F9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8E3E5-F1FD-DF45-89A5-58399262ED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1984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BD965C-CC87-EB13-0CF9-A89FABEF7B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3473D7-02FB-DF88-D2C3-BCB8EED8F5C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149EEC0-12FE-FEE4-8B46-60E752AAB9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7064CE7-BE58-4FE1-45F6-9DBFC9C945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049CF-3B41-CE4E-A914-E9AF9A7E19C3}" type="datetimeFigureOut">
              <a:rPr lang="en-US" smtClean="0"/>
              <a:t>2/27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E9CE33-C871-4E31-6FE1-8F76B910F3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96557E6-6BE3-E785-453F-48E72E1A11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8E3E5-F1FD-DF45-89A5-58399262ED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21161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17545F-55CB-B024-9E23-F18855C375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28BA7D3-AD10-86EF-ACCD-AEC50E9F2CB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9CA4446-5D62-D24E-530A-FB94816650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F8C6E9-B20E-913F-12D7-CD0D336E21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049CF-3B41-CE4E-A914-E9AF9A7E19C3}" type="datetimeFigureOut">
              <a:rPr lang="en-US" smtClean="0"/>
              <a:t>2/27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2153442-5709-7FB2-F709-051D3F2497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679CBF-5C13-1785-379D-19D25AEB8E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58E3E5-F1FD-DF45-89A5-58399262ED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70522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DD5984A-3FB0-B24E-EC97-8C2478452E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F0223DB-22E0-2284-4C5A-14BD1EE21C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40C8B3-0B96-DCA8-3EB0-7A495280EF1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5049CF-3B41-CE4E-A914-E9AF9A7E19C3}" type="datetimeFigureOut">
              <a:rPr lang="en-US" smtClean="0"/>
              <a:t>2/2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277D98-25BF-28F9-97DD-3A163E5AB04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2AAAD2-BC42-BE19-32D2-5A2D5E8FFE2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58E3E5-F1FD-DF45-89A5-58399262ED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29538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file:///C:/Users/yeti/Library/Group%2520Containers/UBF8T346G9.ms/WebArchiveCopyPasteTempFiles/com.microsoft.Word/ECG-Inferior-AMI-STEMI-2.jpg" TargetMode="Externa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file:///C:/Users/yeti/Library/Group%2520Containers/UBF8T346G9.ms/WebArchiveCopyPasteTempFiles/com.microsoft.Word/76052f7902246ff862f52f5d3cd9cd_jumbo.jpg" TargetMode="Externa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034" name="Rectangle 1033">
            <a:extLst>
              <a:ext uri="{FF2B5EF4-FFF2-40B4-BE49-F238E27FC236}">
                <a16:creationId xmlns:a16="http://schemas.microsoft.com/office/drawing/2014/main" id="{53F29798-D584-4792-9B62-3F5F5C36D61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C815F991-DB1B-2239-0684-559D111FE9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84805"/>
            <a:ext cx="10515600" cy="1505883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5200" kern="1200">
                <a:solidFill>
                  <a:schemeClr val="tx1"/>
                </a:solidFill>
                <a:latin typeface="+mj-lt"/>
                <a:ea typeface="+mj-ea"/>
                <a:cs typeface="+mj-cs"/>
              </a:rPr>
              <a:t>Stimulus 1: ECG</a:t>
            </a:r>
          </a:p>
        </p:txBody>
      </p:sp>
      <p:pic>
        <p:nvPicPr>
          <p:cNvPr id="1029" name="Picture 1" descr="A picture containing text, line&#10;&#10;Description automatically generated">
            <a:extLst>
              <a:ext uri="{FF2B5EF4-FFF2-40B4-BE49-F238E27FC236}">
                <a16:creationId xmlns:a16="http://schemas.microsoft.com/office/drawing/2014/main" id="{C5D5F3AE-3FAE-7C72-A546-7BC4618A732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r:link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838200" y="2204600"/>
            <a:ext cx="10512547" cy="37319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6">
            <a:extLst>
              <a:ext uri="{FF2B5EF4-FFF2-40B4-BE49-F238E27FC236}">
                <a16:creationId xmlns:a16="http://schemas.microsoft.com/office/drawing/2014/main" id="{6E205F46-5AD7-1276-DAD6-6AD9B84D1A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27350" y="223837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60759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0C17EA-F099-8D32-D763-732C63A6CC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timulus 2: CBC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AFF0F5-B269-3F8C-C3F8-B4AEE56349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Complete blood count (CBC)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White blood count(WBC)		                  16.0 x1000/mm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3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Hemoglobin(Hgb)			 14.1 g/d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Hematocrit(HCT)			 41.0%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latelets(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lt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</a:t>
            </a:r>
            <a:r>
              <a:rPr lang="en-US" sz="180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	                                                 450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x1000/mm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3</a:t>
            </a:r>
            <a:r>
              <a:rPr lang="en-US" dirty="0">
                <a:effectLst/>
              </a:rPr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495754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4553EF-0740-DA85-D78C-DA34FB2C55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timulus 3: BMP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839E36-1816-02B4-15AC-E380120DC44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Basic metabolic panel(BMP)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Sodium(Na) 				134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mEq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/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Potassium(K) 3.4			3.4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mEq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/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Chloride(Cl) 105			                105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mEq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/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Bicarbonate(HCO</a:t>
            </a:r>
            <a:r>
              <a:rPr lang="en-US" sz="1800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3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) 18		                18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mEq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/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Blood Urea Nitrogen(BUN) 5		5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mEq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/L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reatinine(Cr) 0.8			0.8 mg/dL</a:t>
            </a:r>
            <a:r>
              <a:rPr lang="en-US" dirty="0">
                <a:effectLst/>
              </a:rPr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117079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F7CFB0-F9E5-1DEA-2B23-C15C832051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Stimulus 4: CXR</a:t>
            </a:r>
            <a:endParaRPr lang="en-US" dirty="0"/>
          </a:p>
        </p:txBody>
      </p:sp>
      <p:sp>
        <p:nvSpPr>
          <p:cNvPr id="4" name="Rectangle 2">
            <a:extLst>
              <a:ext uri="{FF2B5EF4-FFF2-40B4-BE49-F238E27FC236}">
                <a16:creationId xmlns:a16="http://schemas.microsoft.com/office/drawing/2014/main" id="{0D3616EB-F8A3-FEFB-6037-0E661D6340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79374" y="1179444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2049" name="Picture 2" descr="A chest x-ray of a person&#10;&#10;Description automatically generated with medium confidence">
            <a:extLst>
              <a:ext uri="{FF2B5EF4-FFF2-40B4-BE49-F238E27FC236}">
                <a16:creationId xmlns:a16="http://schemas.microsoft.com/office/drawing/2014/main" id="{7D3CAFB3-E575-0088-ADA4-91EAAED89E3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r:link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79374" y="1396360"/>
            <a:ext cx="5705297" cy="519328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822418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817C18-24E5-B6CC-5D70-BBBF401244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timulus 5: Troponi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66C84C-5F2C-54EE-DBE3-579B9C9F1B3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ardiac Biomarker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roponin				124, 071 ng/L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382497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225</Words>
  <Application>Microsoft Macintosh PowerPoint</Application>
  <PresentationFormat>Widescreen</PresentationFormat>
  <Paragraphs>23</Paragraphs>
  <Slides>5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Stimulus 1: ECG</vt:lpstr>
      <vt:lpstr>Stimulus 2: CBC</vt:lpstr>
      <vt:lpstr>Stimulus 3: BMP</vt:lpstr>
      <vt:lpstr>Stimulus 4: CXR</vt:lpstr>
      <vt:lpstr>Stimulus 5: Troponi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timulus 1: ECG</dc:title>
  <dc:creator>Steratore, Anthony</dc:creator>
  <cp:lastModifiedBy>Steratore, Anthony</cp:lastModifiedBy>
  <cp:revision>1</cp:revision>
  <dcterms:created xsi:type="dcterms:W3CDTF">2024-02-27T20:18:45Z</dcterms:created>
  <dcterms:modified xsi:type="dcterms:W3CDTF">2024-02-27T20:54:55Z</dcterms:modified>
</cp:coreProperties>
</file>